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91DA6E-295B-4C19-967A-E7C3C538C08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93F2C0-6DC1-4FAE-A123-6621D00698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94DAC-11C2-4043-91A1-2426D5EF0AC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5E00E-3001-4843-9555-B81FD72C7F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6D933-4B3F-444F-9093-72EBFDBAE4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016AF-A338-47CF-8B17-86D5676A51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2F636-3F93-47BC-B8B7-C0A6539041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CA4DBE-BFAB-40A0-8BA8-90214F8B88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D7A5B-E1ED-4417-ACF8-CF2AE0348B3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856CCE-17ED-44FE-9F8A-86B535A145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F208D2-97F4-4AC1-BB78-7DDE1867A9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5B3108-46B9-42E3-B091-B22D6F78B5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F0074B4-0869-42A3-9B98-FECB83FC68D8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hteck 1040"/>
          <p:cNvSpPr/>
          <p:nvPr/>
        </p:nvSpPr>
        <p:spPr>
          <a:xfrm>
            <a:off x="3492360" y="1681200"/>
            <a:ext cx="419400" cy="390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Ellipse 1042"/>
          <p:cNvSpPr/>
          <p:nvPr/>
        </p:nvSpPr>
        <p:spPr>
          <a:xfrm>
            <a:off x="4387680" y="1681200"/>
            <a:ext cx="476280" cy="428760"/>
          </a:xfrm>
          <a:prstGeom prst="ellips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Ellipse 1045"/>
          <p:cNvSpPr/>
          <p:nvPr/>
        </p:nvSpPr>
        <p:spPr>
          <a:xfrm>
            <a:off x="4152960" y="3094200"/>
            <a:ext cx="476280" cy="428400"/>
          </a:xfrm>
          <a:prstGeom prst="ellips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Ellipse 1046"/>
          <p:cNvSpPr/>
          <p:nvPr/>
        </p:nvSpPr>
        <p:spPr>
          <a:xfrm>
            <a:off x="2406600" y="3100320"/>
            <a:ext cx="476280" cy="428760"/>
          </a:xfrm>
          <a:prstGeom prst="ellips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hteck 1048"/>
          <p:cNvSpPr/>
          <p:nvPr/>
        </p:nvSpPr>
        <p:spPr>
          <a:xfrm>
            <a:off x="3309840" y="3112920"/>
            <a:ext cx="419040" cy="390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Rechteck 1051"/>
          <p:cNvSpPr/>
          <p:nvPr/>
        </p:nvSpPr>
        <p:spPr>
          <a:xfrm>
            <a:off x="1203480" y="3133800"/>
            <a:ext cx="419040" cy="390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Rechteck 1052"/>
          <p:cNvSpPr/>
          <p:nvPr/>
        </p:nvSpPr>
        <p:spPr>
          <a:xfrm>
            <a:off x="1303200" y="4819680"/>
            <a:ext cx="419400" cy="39060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Ellipse 1054"/>
          <p:cNvSpPr/>
          <p:nvPr/>
        </p:nvSpPr>
        <p:spPr>
          <a:xfrm>
            <a:off x="2227320" y="4780080"/>
            <a:ext cx="476280" cy="428400"/>
          </a:xfrm>
          <a:prstGeom prst="ellips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Gerade Verbindung 1055"/>
          <p:cNvSpPr/>
          <p:nvPr/>
        </p:nvSpPr>
        <p:spPr>
          <a:xfrm>
            <a:off x="3911760" y="1871640"/>
            <a:ext cx="4759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Gerade Verbindung 288"/>
          <p:cNvSpPr/>
          <p:nvPr/>
        </p:nvSpPr>
        <p:spPr>
          <a:xfrm>
            <a:off x="4168800" y="1871640"/>
            <a:ext cx="0" cy="7239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Gerade Verbindung 289"/>
          <p:cNvSpPr/>
          <p:nvPr/>
        </p:nvSpPr>
        <p:spPr>
          <a:xfrm flipH="1">
            <a:off x="2637000" y="2595600"/>
            <a:ext cx="30477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Gerade Verbindung 295"/>
          <p:cNvSpPr/>
          <p:nvPr/>
        </p:nvSpPr>
        <p:spPr>
          <a:xfrm>
            <a:off x="1612800" y="3319560"/>
            <a:ext cx="7905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Gerade Verbindung 296"/>
          <p:cNvSpPr/>
          <p:nvPr/>
        </p:nvSpPr>
        <p:spPr>
          <a:xfrm>
            <a:off x="1503360" y="4498920"/>
            <a:ext cx="9619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Gerade Verbindung 297"/>
          <p:cNvSpPr/>
          <p:nvPr/>
        </p:nvSpPr>
        <p:spPr>
          <a:xfrm>
            <a:off x="1512720" y="4486320"/>
            <a:ext cx="0" cy="3236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Gerade Verbindung 298"/>
          <p:cNvSpPr/>
          <p:nvPr/>
        </p:nvSpPr>
        <p:spPr>
          <a:xfrm>
            <a:off x="2454120" y="4486320"/>
            <a:ext cx="9720" cy="28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Gerade Verbindung 299"/>
          <p:cNvSpPr/>
          <p:nvPr/>
        </p:nvSpPr>
        <p:spPr>
          <a:xfrm>
            <a:off x="1984320" y="3313080"/>
            <a:ext cx="0" cy="1198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Ellipse 300"/>
          <p:cNvSpPr/>
          <p:nvPr/>
        </p:nvSpPr>
        <p:spPr>
          <a:xfrm>
            <a:off x="4549680" y="1843200"/>
            <a:ext cx="152640" cy="1238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1040" bIns="4104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Gerade Verbindung 288"/>
          <p:cNvSpPr/>
          <p:nvPr/>
        </p:nvSpPr>
        <p:spPr>
          <a:xfrm>
            <a:off x="4398840" y="2589120"/>
            <a:ext cx="0" cy="5079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Gerade Verbindung 288"/>
          <p:cNvSpPr/>
          <p:nvPr/>
        </p:nvSpPr>
        <p:spPr>
          <a:xfrm>
            <a:off x="3525840" y="2592360"/>
            <a:ext cx="0" cy="5079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Gerade Verbindung 288"/>
          <p:cNvSpPr/>
          <p:nvPr/>
        </p:nvSpPr>
        <p:spPr>
          <a:xfrm>
            <a:off x="2637000" y="2595600"/>
            <a:ext cx="0" cy="5079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Gerade Verbindung 290"/>
          <p:cNvSpPr/>
          <p:nvPr/>
        </p:nvSpPr>
        <p:spPr>
          <a:xfrm flipH="1">
            <a:off x="3420720" y="1617840"/>
            <a:ext cx="576360" cy="5047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42"/>
          <p:cNvSpPr/>
          <p:nvPr/>
        </p:nvSpPr>
        <p:spPr>
          <a:xfrm>
            <a:off x="2124000" y="5257800"/>
            <a:ext cx="102888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8000"/>
                </a:solidFill>
                <a:latin typeface="Calibri"/>
                <a:ea typeface="Times New Roman"/>
              </a:rPr>
              <a:t>No skew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43"/>
          <p:cNvSpPr/>
          <p:nvPr/>
        </p:nvSpPr>
        <p:spPr>
          <a:xfrm>
            <a:off x="2130480" y="3902040"/>
            <a:ext cx="102852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85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8000"/>
                </a:solidFill>
                <a:latin typeface="Calibri"/>
                <a:ea typeface="Times New Roman"/>
              </a:rPr>
              <a:t>Complete skew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 Box 44"/>
          <p:cNvSpPr/>
          <p:nvPr/>
        </p:nvSpPr>
        <p:spPr>
          <a:xfrm>
            <a:off x="4000680" y="3922560"/>
            <a:ext cx="102852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86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8000"/>
                </a:solidFill>
                <a:latin typeface="Calibri"/>
                <a:ea typeface="Times New Roman"/>
              </a:rPr>
              <a:t>Complete skew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45"/>
          <p:cNvSpPr/>
          <p:nvPr/>
        </p:nvSpPr>
        <p:spPr>
          <a:xfrm>
            <a:off x="4861080" y="3600360"/>
            <a:ext cx="102852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8000"/>
                </a:solidFill>
                <a:latin typeface="Calibri"/>
                <a:ea typeface="Times New Roman"/>
              </a:rPr>
              <a:t>No skewing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48"/>
          <p:cNvSpPr/>
          <p:nvPr/>
        </p:nvSpPr>
        <p:spPr>
          <a:xfrm>
            <a:off x="4284720" y="2089080"/>
            <a:ext cx="167652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 fontScale="86000"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8000"/>
                </a:solidFill>
                <a:latin typeface="Calibri"/>
                <a:ea typeface="Times New Roman"/>
              </a:rPr>
              <a:t>X-inactivation analysis not informativ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27"/>
          <p:cNvSpPr/>
          <p:nvPr/>
        </p:nvSpPr>
        <p:spPr>
          <a:xfrm>
            <a:off x="1160640" y="5259240"/>
            <a:ext cx="1190520" cy="648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UBE2A_Exon4,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c.C236G, p.P79R, hemizygou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28"/>
          <p:cNvSpPr/>
          <p:nvPr/>
        </p:nvSpPr>
        <p:spPr>
          <a:xfrm>
            <a:off x="5757840" y="3621240"/>
            <a:ext cx="1190520" cy="647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UBE2A_Exon4,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Times New Roman"/>
              </a:rPr>
              <a:t>c.C236G, p.P79R, hemizygou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9" name="Picture 50" descr=""/>
          <p:cNvPicPr/>
          <p:nvPr/>
        </p:nvPicPr>
        <p:blipFill>
          <a:blip r:embed="rId1"/>
          <a:srcRect l="0" t="27939" r="0" b="0"/>
          <a:stretch/>
        </p:blipFill>
        <p:spPr>
          <a:xfrm>
            <a:off x="7380360" y="4340160"/>
            <a:ext cx="1155600" cy="1295640"/>
          </a:xfrm>
          <a:prstGeom prst="rect">
            <a:avLst/>
          </a:prstGeom>
          <a:ln w="0">
            <a:noFill/>
          </a:ln>
        </p:spPr>
      </p:pic>
      <p:sp>
        <p:nvSpPr>
          <p:cNvPr id="70" name="Ellipse 1043"/>
          <p:cNvSpPr/>
          <p:nvPr/>
        </p:nvSpPr>
        <p:spPr>
          <a:xfrm>
            <a:off x="5038560" y="3125880"/>
            <a:ext cx="476280" cy="428400"/>
          </a:xfrm>
          <a:prstGeom prst="ellips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hteck 1049"/>
          <p:cNvSpPr/>
          <p:nvPr/>
        </p:nvSpPr>
        <p:spPr>
          <a:xfrm>
            <a:off x="5952960" y="3146400"/>
            <a:ext cx="419400" cy="39060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Gerade Verbindung 290"/>
          <p:cNvSpPr/>
          <p:nvPr/>
        </p:nvSpPr>
        <p:spPr>
          <a:xfrm flipH="1">
            <a:off x="5327280" y="2597040"/>
            <a:ext cx="352440" cy="5256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Gerade Verbindung 293"/>
          <p:cNvSpPr/>
          <p:nvPr/>
        </p:nvSpPr>
        <p:spPr>
          <a:xfrm>
            <a:off x="5673600" y="2593800"/>
            <a:ext cx="517680" cy="6001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Ellipse 301"/>
          <p:cNvSpPr/>
          <p:nvPr/>
        </p:nvSpPr>
        <p:spPr>
          <a:xfrm>
            <a:off x="4317840" y="3246480"/>
            <a:ext cx="152640" cy="12384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1040" bIns="4104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Ellipse 302"/>
          <p:cNvSpPr/>
          <p:nvPr/>
        </p:nvSpPr>
        <p:spPr>
          <a:xfrm>
            <a:off x="2568600" y="3252960"/>
            <a:ext cx="152280" cy="123480"/>
          </a:xfrm>
          <a:prstGeom prst="ellipse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0680" bIns="4068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29"/>
          <p:cNvSpPr/>
          <p:nvPr/>
        </p:nvSpPr>
        <p:spPr>
          <a:xfrm>
            <a:off x="3989520" y="3529080"/>
            <a:ext cx="94284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UBE2A_Exon4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c.C236G, p.P79R, heterozygo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30"/>
          <p:cNvSpPr/>
          <p:nvPr/>
        </p:nvSpPr>
        <p:spPr>
          <a:xfrm>
            <a:off x="2124000" y="3529080"/>
            <a:ext cx="94320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UBE2A_Exon4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c.C236G, p.P79R, heterozygo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Picture 47" descr=""/>
          <p:cNvPicPr/>
          <p:nvPr/>
        </p:nvPicPr>
        <p:blipFill>
          <a:blip r:embed="rId2">
            <a:alphaModFix amt="15000"/>
          </a:blip>
          <a:srcRect l="0" t="23607" r="0" b="0"/>
          <a:stretch/>
        </p:blipFill>
        <p:spPr>
          <a:xfrm>
            <a:off x="7397640" y="2751120"/>
            <a:ext cx="1173240" cy="1228680"/>
          </a:xfrm>
          <a:prstGeom prst="rect">
            <a:avLst/>
          </a:prstGeom>
          <a:ln w="0">
            <a:noFill/>
          </a:ln>
        </p:spPr>
      </p:pic>
      <p:sp>
        <p:nvSpPr>
          <p:cNvPr id="79" name="Text Box 61"/>
          <p:cNvSpPr/>
          <p:nvPr/>
        </p:nvSpPr>
        <p:spPr>
          <a:xfrm>
            <a:off x="4846680" y="1709640"/>
            <a:ext cx="942840" cy="52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UBE2A_Exon4,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c.C236G, p.P79R, heterozygo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63"/>
          <p:cNvSpPr/>
          <p:nvPr/>
        </p:nvSpPr>
        <p:spPr>
          <a:xfrm>
            <a:off x="1109520" y="3548160"/>
            <a:ext cx="943200" cy="52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UBE2A  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 Box 64"/>
          <p:cNvSpPr/>
          <p:nvPr/>
        </p:nvSpPr>
        <p:spPr>
          <a:xfrm>
            <a:off x="3216240" y="3519360"/>
            <a:ext cx="942840" cy="52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Calibri"/>
                <a:ea typeface="Times New Roman"/>
              </a:rPr>
              <a:t>UBE2A  w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Rectangle 58"/>
          <p:cNvSpPr/>
          <p:nvPr/>
        </p:nvSpPr>
        <p:spPr>
          <a:xfrm>
            <a:off x="7420320" y="3908160"/>
            <a:ext cx="1102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female carri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Rectangle 60"/>
          <p:cNvSpPr/>
          <p:nvPr/>
        </p:nvSpPr>
        <p:spPr>
          <a:xfrm>
            <a:off x="7421400" y="5563800"/>
            <a:ext cx="107820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100" spc="-1" strike="noStrike">
                <a:solidFill>
                  <a:srgbClr val="000000"/>
                </a:solidFill>
                <a:latin typeface="Arial"/>
              </a:rPr>
              <a:t>affected mal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4" name="Picture 52" descr=""/>
          <p:cNvPicPr/>
          <p:nvPr/>
        </p:nvPicPr>
        <p:blipFill>
          <a:blip r:embed="rId3"/>
          <a:srcRect l="0" t="23216" r="0" b="0"/>
          <a:stretch/>
        </p:blipFill>
        <p:spPr>
          <a:xfrm>
            <a:off x="7400880" y="1055520"/>
            <a:ext cx="1103400" cy="1297080"/>
          </a:xfrm>
          <a:prstGeom prst="rect">
            <a:avLst/>
          </a:prstGeom>
          <a:ln w="0">
            <a:noFill/>
          </a:ln>
        </p:spPr>
      </p:pic>
      <p:sp>
        <p:nvSpPr>
          <p:cNvPr id="85" name="Rectangle 62"/>
          <p:cNvSpPr/>
          <p:nvPr/>
        </p:nvSpPr>
        <p:spPr>
          <a:xfrm>
            <a:off x="7616160" y="2279160"/>
            <a:ext cx="7430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100" spc="-1" strike="noStrike">
                <a:solidFill>
                  <a:srgbClr val="000000"/>
                </a:solidFill>
                <a:latin typeface="Arial"/>
              </a:rPr>
              <a:t>wildtyp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Rechteck 1040"/>
          <p:cNvSpPr/>
          <p:nvPr/>
        </p:nvSpPr>
        <p:spPr>
          <a:xfrm>
            <a:off x="3960720" y="731880"/>
            <a:ext cx="419040" cy="390600"/>
          </a:xfrm>
          <a:prstGeom prst="rect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Ellipse 1042"/>
          <p:cNvSpPr/>
          <p:nvPr/>
        </p:nvSpPr>
        <p:spPr>
          <a:xfrm>
            <a:off x="4856040" y="731880"/>
            <a:ext cx="476280" cy="428760"/>
          </a:xfrm>
          <a:prstGeom prst="ellips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Gerade Verbindung 1055"/>
          <p:cNvSpPr/>
          <p:nvPr/>
        </p:nvSpPr>
        <p:spPr>
          <a:xfrm>
            <a:off x="4379760" y="922320"/>
            <a:ext cx="4762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Gerade Verbindung 290"/>
          <p:cNvSpPr/>
          <p:nvPr/>
        </p:nvSpPr>
        <p:spPr>
          <a:xfrm flipH="1">
            <a:off x="3889080" y="673200"/>
            <a:ext cx="576360" cy="5047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Gerade Verbindung 290"/>
          <p:cNvSpPr/>
          <p:nvPr/>
        </p:nvSpPr>
        <p:spPr>
          <a:xfrm flipH="1">
            <a:off x="4853160" y="673200"/>
            <a:ext cx="576000" cy="5047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Gerade Verbindung 288"/>
          <p:cNvSpPr/>
          <p:nvPr/>
        </p:nvSpPr>
        <p:spPr>
          <a:xfrm>
            <a:off x="4643280" y="949320"/>
            <a:ext cx="0" cy="7239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Gerade Verbindung 299"/>
          <p:cNvSpPr/>
          <p:nvPr/>
        </p:nvSpPr>
        <p:spPr>
          <a:xfrm flipH="1">
            <a:off x="5087880" y="458640"/>
            <a:ext cx="119880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Gerade Verbindung 298"/>
          <p:cNvSpPr/>
          <p:nvPr/>
        </p:nvSpPr>
        <p:spPr>
          <a:xfrm>
            <a:off x="5072040" y="458640"/>
            <a:ext cx="9720" cy="28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Gerade Verbindung 298"/>
          <p:cNvSpPr/>
          <p:nvPr/>
        </p:nvSpPr>
        <p:spPr>
          <a:xfrm>
            <a:off x="6276960" y="458640"/>
            <a:ext cx="9720" cy="2858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Ellipse 1042"/>
          <p:cNvSpPr/>
          <p:nvPr/>
        </p:nvSpPr>
        <p:spPr>
          <a:xfrm>
            <a:off x="6070680" y="731880"/>
            <a:ext cx="476280" cy="428760"/>
          </a:xfrm>
          <a:prstGeom prst="ellipse">
            <a:avLst/>
          </a:prstGeom>
          <a:noFill/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Gerade Verbindung 290"/>
          <p:cNvSpPr/>
          <p:nvPr/>
        </p:nvSpPr>
        <p:spPr>
          <a:xfrm flipH="1">
            <a:off x="6067080" y="673200"/>
            <a:ext cx="576360" cy="50472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Gerade Verbindung 288"/>
          <p:cNvSpPr/>
          <p:nvPr/>
        </p:nvSpPr>
        <p:spPr>
          <a:xfrm>
            <a:off x="6318360" y="1173240"/>
            <a:ext cx="0" cy="50796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Ellipse 1043"/>
          <p:cNvSpPr/>
          <p:nvPr/>
        </p:nvSpPr>
        <p:spPr>
          <a:xfrm>
            <a:off x="6086520" y="1674720"/>
            <a:ext cx="476280" cy="428760"/>
          </a:xfrm>
          <a:prstGeom prst="ellipse">
            <a:avLst/>
          </a:prstGeom>
          <a:blipFill rotWithShape="0">
            <a:blip r:embed="rId4"/>
            <a:srcRect/>
            <a:tile tx="0" ty="0" sx="100000" sy="100000" algn="ctr"/>
          </a:blip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feld 1"/>
          <p:cNvSpPr/>
          <p:nvPr/>
        </p:nvSpPr>
        <p:spPr>
          <a:xfrm>
            <a:off x="6149520" y="1674720"/>
            <a:ext cx="351360" cy="42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2200" spc="-1" strike="noStrike">
                <a:solidFill>
                  <a:srgbClr val="c6d9f1"/>
                </a:solidFill>
                <a:latin typeface="Arial"/>
              </a:rPr>
              <a:t>?</a:t>
            </a:r>
            <a:endParaRPr b="0" lang="en-US" sz="2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Ellipse 1043"/>
          <p:cNvSpPr/>
          <p:nvPr/>
        </p:nvSpPr>
        <p:spPr>
          <a:xfrm>
            <a:off x="3860640" y="5902200"/>
            <a:ext cx="235080" cy="219240"/>
          </a:xfrm>
          <a:prstGeom prst="ellipse">
            <a:avLst/>
          </a:prstGeom>
          <a:blipFill rotWithShape="0">
            <a:blip r:embed="rId5"/>
            <a:srcRect/>
            <a:tile tx="0" ty="0" sx="100000" sy="100000" algn="ctr"/>
          </a:blip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rm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Rechteck 2"/>
          <p:cNvSpPr/>
          <p:nvPr/>
        </p:nvSpPr>
        <p:spPr>
          <a:xfrm>
            <a:off x="4121280" y="5877000"/>
            <a:ext cx="1665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ID of unknown etiolog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feld 63"/>
          <p:cNvSpPr/>
          <p:nvPr/>
        </p:nvSpPr>
        <p:spPr>
          <a:xfrm>
            <a:off x="1215000" y="588816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at.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Line 107"/>
          <p:cNvSpPr/>
          <p:nvPr/>
        </p:nvSpPr>
        <p:spPr>
          <a:xfrm flipV="1">
            <a:off x="5745240" y="3560760"/>
            <a:ext cx="158760" cy="24120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Line 107"/>
          <p:cNvSpPr/>
          <p:nvPr/>
        </p:nvSpPr>
        <p:spPr>
          <a:xfrm flipV="1">
            <a:off x="1089000" y="5214600"/>
            <a:ext cx="158760" cy="243000"/>
          </a:xfrm>
          <a:prstGeom prst="line">
            <a:avLst/>
          </a:prstGeom>
          <a:ln w="38160">
            <a:solidFill>
              <a:srgbClr val="ff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feld 66"/>
          <p:cNvSpPr/>
          <p:nvPr/>
        </p:nvSpPr>
        <p:spPr>
          <a:xfrm>
            <a:off x="5870880" y="4232160"/>
            <a:ext cx="57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pat. 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9T06:23:50Z</dcterms:created>
  <dc:creator>Alma Küchler</dc:creator>
  <dc:description/>
  <dc:language>en-US</dc:language>
  <cp:lastModifiedBy>Alma Küchler</cp:lastModifiedBy>
  <dcterms:modified xsi:type="dcterms:W3CDTF">2013-09-03T07:44:51Z</dcterms:modified>
  <cp:revision>12</cp:revision>
  <dc:subject/>
  <dc:title>PowerPoint-Präsentation</dc:title>
</cp:coreProperties>
</file>